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en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93" autoAdjust="0"/>
    <p:restoredTop sz="94660"/>
  </p:normalViewPr>
  <p:slideViewPr>
    <p:cSldViewPr snapToGrid="0" showGuides="1">
      <p:cViewPr varScale="1">
        <p:scale>
          <a:sx n="82" d="100"/>
          <a:sy n="82" d="100"/>
        </p:scale>
        <p:origin x="126" y="34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AC75DA-876C-9814-7DE4-179093D6848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C5BA292-FE38-AEFF-D734-A5DE75EE379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341F4E-8D10-0C49-A11F-F8BB6ACDF4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60E3A5-A250-A72D-0655-8681028415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3E4995-1A25-5613-3CB7-F8F1FBCA1B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1165811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153C7E-249C-C608-C640-68C35A1FFF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16A180C-B2AB-BFA0-1DD2-C57FFCE6D5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D53947-AF88-AD42-11FB-5027FC7703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91670A-E8BF-FBE7-B76E-6AAB0061A1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D2F002-18E4-F467-0691-217B8C1193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0329213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09086AB-956A-6EF1-5DBB-DC43E5DBA19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44E7BCA-4ADA-1998-0E0E-F5021CC4F3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248976-69F8-ED46-0B5C-F590C0710C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7D4A30-63B2-A4DD-4502-3B1DDB582C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78DD4B-AD6E-9022-46A0-57067D699D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9898131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156398-2E91-DCCA-7A89-1D84D13785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DCC001-5649-AB4E-6494-ACD12990FE9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78D962-9ED6-6567-7417-E76244A7FC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E149EF-7CD2-8C65-7EEB-76B4D83A3D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18CDEF-2DDF-E3D9-3B5E-61A639C609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5242059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F82F80-993F-D2FB-0DBA-485FD4D8FF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F56A2D8-14C2-C746-3B1D-933005CAF8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1437D5-A396-81BA-47E0-EEEFE0AFB3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6855B5-4FF2-A87D-2D42-1C91F9C53A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3100FB-51DD-A3CD-2E67-524D388911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0730980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228DD7-A945-C1E3-815F-26FD23C195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A54B4C6-90E7-8E99-6217-194852FC0D0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D02E0C6-144D-ECB8-72A3-2748FD7AE3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43D97D-D2D0-176E-562F-6CFEEC3FE4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62ABEDC-26DF-E91A-B279-A0E42BB3AE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E0BB212-CE38-9BFC-1BEE-003AE576C8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9784425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006D5F-0CE7-3109-267A-DDE0F6EEDD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ACE52BF-CBF4-9A79-43C2-00FD8F6046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8ED3AA0-6116-EEB4-2ADD-46D16E7A9A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DA17345-989F-CAFF-E538-29AECBE2AEC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4AAA2BB-06A9-515E-E6D7-40B6761B8A5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24B79C1-3F57-F46E-C41E-754344EB6C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AD21308-54ED-803A-630E-076B9A4256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E54443E-6521-6B03-E4A5-0DF282F47E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7990429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5FE944-4B0A-DBE3-1026-336F0EA6D6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1D9B25A-F645-7109-DFD8-8A3E209DC0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B3639BA-8140-AFE8-E84A-5AE1DB01F1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05D4F7E-18F3-E380-29A4-A761E131AB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3387314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DECAAC5-A8F4-D635-2AF1-B6AF071C8F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20E0357-85EC-A8C4-13EE-E9DF67E411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A465C70-5E4A-37F7-0442-2A0CBD8EE1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6566154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185375-7F61-062D-AB1C-DF9C5654B2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B03E477-406E-C5F5-4B78-E5E53C0548E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87B9FAC-3F01-D384-6DA5-DF78FA169F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965789E-63D7-54B7-0C33-A70C241BF4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287737B-EC50-0FEF-DA55-B81A8B1A34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0094EC0-CEAE-21D8-8AE5-5B165533CF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3374772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DD1A9F-C6F0-792B-050C-29C4DFDFD9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FE15C31-1847-8321-3FB3-09E6B813D7B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D3766E6-64D7-4E38-1599-707BD73E38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16E8DF5-E161-B255-0C7B-9FABBF9CCA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FA97C65-43FA-49B8-125B-AC7F7FA259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517EA60-AE12-BB00-E775-17EE0201D8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2422843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81378DE-852B-CFB7-9A7A-0835366275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D1828B3-FE3D-3926-B625-63B9F59B69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B7AED3-ED14-68E6-52DD-3E815FF5F7B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41B404-05E3-EF5C-F3ED-A45358ABC61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E35E14-3BAD-3053-0D55-C41CCC65FB1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0616706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669C23C2-6369-4DAA-92E8-FF7DACE9D4F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100" t="43855" r="57" b="5199"/>
          <a:stretch/>
        </p:blipFill>
        <p:spPr bwMode="auto">
          <a:xfrm>
            <a:off x="4134678" y="2888971"/>
            <a:ext cx="4162129" cy="3107635"/>
          </a:xfrm>
          <a:prstGeom prst="rect">
            <a:avLst/>
          </a:prstGeom>
          <a:ln>
            <a:noFill/>
          </a:ln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44DCC9BA-2924-4073-9D0C-A2C099F0F249}"/>
              </a:ext>
            </a:extLst>
          </p:cNvPr>
          <p:cNvSpPr/>
          <p:nvPr/>
        </p:nvSpPr>
        <p:spPr>
          <a:xfrm>
            <a:off x="4592595" y="3841471"/>
            <a:ext cx="2772000" cy="29217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A430F5C-A61E-44E3-8A3A-73C3245B0161}"/>
              </a:ext>
            </a:extLst>
          </p:cNvPr>
          <p:cNvSpPr txBox="1"/>
          <p:nvPr/>
        </p:nvSpPr>
        <p:spPr>
          <a:xfrm>
            <a:off x="7822512" y="3833667"/>
            <a:ext cx="6527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LKL</a:t>
            </a:r>
            <a:endParaRPr lang="en-DE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2D0B659-C7E9-2084-B63A-3A20BD206BA4}"/>
              </a:ext>
            </a:extLst>
          </p:cNvPr>
          <p:cNvSpPr txBox="1"/>
          <p:nvPr/>
        </p:nvSpPr>
        <p:spPr>
          <a:xfrm rot="16200000">
            <a:off x="4588504" y="2492852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DD5D739-36F6-E45E-C114-B58859049F34}"/>
              </a:ext>
            </a:extLst>
          </p:cNvPr>
          <p:cNvSpPr txBox="1"/>
          <p:nvPr/>
        </p:nvSpPr>
        <p:spPr>
          <a:xfrm rot="16200000">
            <a:off x="5226161" y="1283114"/>
            <a:ext cx="280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 (moderate)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AAA15CF-ACB3-600A-76EB-F2DEA4857511}"/>
              </a:ext>
            </a:extLst>
          </p:cNvPr>
          <p:cNvSpPr txBox="1"/>
          <p:nvPr/>
        </p:nvSpPr>
        <p:spPr>
          <a:xfrm rot="16200000">
            <a:off x="4766621" y="2204231"/>
            <a:ext cx="9877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10CB60E-D6F1-E7B4-EE5E-AD2C4481B7D7}"/>
              </a:ext>
            </a:extLst>
          </p:cNvPr>
          <p:cNvSpPr txBox="1"/>
          <p:nvPr/>
        </p:nvSpPr>
        <p:spPr>
          <a:xfrm rot="16200000">
            <a:off x="5525910" y="2083857"/>
            <a:ext cx="13003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mZ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L-NG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A4DC12A-3BD5-2104-1029-F4E3FCE4E9D7}"/>
              </a:ext>
            </a:extLst>
          </p:cNvPr>
          <p:cNvSpPr txBox="1"/>
          <p:nvPr/>
        </p:nvSpPr>
        <p:spPr>
          <a:xfrm rot="16200000">
            <a:off x="5244299" y="2256981"/>
            <a:ext cx="9541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941A9EE-6433-5FB5-246E-C9FC1BA5F71F}"/>
              </a:ext>
            </a:extLst>
          </p:cNvPr>
          <p:cNvSpPr txBox="1"/>
          <p:nvPr/>
        </p:nvSpPr>
        <p:spPr>
          <a:xfrm rot="16200000">
            <a:off x="5687007" y="1329371"/>
            <a:ext cx="280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 (high)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95BF36BD-2CED-6C4A-AD1E-516BE06FE881}"/>
              </a:ext>
            </a:extLst>
          </p:cNvPr>
          <p:cNvCxnSpPr>
            <a:cxnSpLocks/>
          </p:cNvCxnSpPr>
          <p:nvPr/>
        </p:nvCxnSpPr>
        <p:spPr>
          <a:xfrm>
            <a:off x="4609197" y="2836865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164CFADC-9EFD-C37C-5B80-A04BC5449B85}"/>
              </a:ext>
            </a:extLst>
          </p:cNvPr>
          <p:cNvCxnSpPr>
            <a:cxnSpLocks/>
          </p:cNvCxnSpPr>
          <p:nvPr/>
        </p:nvCxnSpPr>
        <p:spPr>
          <a:xfrm>
            <a:off x="5073023" y="2836865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D8ECF2AE-1116-61A9-A879-89C5811CFEB9}"/>
              </a:ext>
            </a:extLst>
          </p:cNvPr>
          <p:cNvCxnSpPr>
            <a:cxnSpLocks/>
          </p:cNvCxnSpPr>
          <p:nvPr/>
        </p:nvCxnSpPr>
        <p:spPr>
          <a:xfrm>
            <a:off x="5533868" y="2836616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0EE10287-5CB1-893D-8A15-217AE4DD64A9}"/>
              </a:ext>
            </a:extLst>
          </p:cNvPr>
          <p:cNvCxnSpPr>
            <a:cxnSpLocks/>
          </p:cNvCxnSpPr>
          <p:nvPr/>
        </p:nvCxnSpPr>
        <p:spPr>
          <a:xfrm>
            <a:off x="5988348" y="2836616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34AEDF10-6BA2-AA07-1F19-79187A5E54D3}"/>
              </a:ext>
            </a:extLst>
          </p:cNvPr>
          <p:cNvCxnSpPr>
            <a:cxnSpLocks/>
          </p:cNvCxnSpPr>
          <p:nvPr/>
        </p:nvCxnSpPr>
        <p:spPr>
          <a:xfrm>
            <a:off x="6437997" y="2839031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0CFA9EFD-CA03-547A-7564-1341ACC71F16}"/>
              </a:ext>
            </a:extLst>
          </p:cNvPr>
          <p:cNvCxnSpPr>
            <a:cxnSpLocks/>
          </p:cNvCxnSpPr>
          <p:nvPr/>
        </p:nvCxnSpPr>
        <p:spPr>
          <a:xfrm>
            <a:off x="6895197" y="2836616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94221D86-D1AC-5237-E32E-C78C1C9FD733}"/>
              </a:ext>
            </a:extLst>
          </p:cNvPr>
          <p:cNvSpPr txBox="1"/>
          <p:nvPr/>
        </p:nvSpPr>
        <p:spPr>
          <a:xfrm>
            <a:off x="4018957" y="2872534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EC96D4D-4242-09F3-F44C-A6E5355F20E6}"/>
              </a:ext>
            </a:extLst>
          </p:cNvPr>
          <p:cNvSpPr txBox="1"/>
          <p:nvPr/>
        </p:nvSpPr>
        <p:spPr>
          <a:xfrm>
            <a:off x="3638152" y="3152001"/>
            <a:ext cx="9092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mricasan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8B83FF4-921B-DBE5-E434-F7A5FDB7668C}"/>
              </a:ext>
            </a:extLst>
          </p:cNvPr>
          <p:cNvSpPr txBox="1"/>
          <p:nvPr/>
        </p:nvSpPr>
        <p:spPr>
          <a:xfrm>
            <a:off x="4544592" y="2855808"/>
            <a:ext cx="2820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Symbol" panose="05050102010706020507" pitchFamily="18" charset="2"/>
                <a:cs typeface="Arial" panose="020B0604020202020204" pitchFamily="34" charset="0"/>
              </a:rPr>
              <a:t>+    +    +    +    +    +    +   +    +   +    +    +</a:t>
            </a:r>
            <a:endParaRPr lang="en-DE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8D82F8B-30BE-8537-C441-07E2580754F7}"/>
              </a:ext>
            </a:extLst>
          </p:cNvPr>
          <p:cNvSpPr txBox="1"/>
          <p:nvPr/>
        </p:nvSpPr>
        <p:spPr>
          <a:xfrm>
            <a:off x="4544592" y="3105194"/>
            <a:ext cx="2820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Symbol" panose="05050102010706020507" pitchFamily="18" charset="2"/>
                <a:cs typeface="Arial" panose="020B0604020202020204" pitchFamily="34" charset="0"/>
              </a:rPr>
              <a:t>-    +    -    +    -    +    -   +    -   +    -    +</a:t>
            </a:r>
            <a:endParaRPr lang="en-DE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64C1C49-7947-C6E6-DCAA-0DD84523697D}"/>
              </a:ext>
            </a:extLst>
          </p:cNvPr>
          <p:cNvSpPr txBox="1"/>
          <p:nvPr/>
        </p:nvSpPr>
        <p:spPr>
          <a:xfrm>
            <a:off x="1014222" y="1025027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ot 1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9D9CED16-3F32-442D-8369-4F5D9B5BF266}"/>
              </a:ext>
            </a:extLst>
          </p:cNvPr>
          <p:cNvCxnSpPr>
            <a:cxnSpLocks/>
          </p:cNvCxnSpPr>
          <p:nvPr/>
        </p:nvCxnSpPr>
        <p:spPr>
          <a:xfrm>
            <a:off x="4214460" y="4309670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TextBox 36">
            <a:extLst>
              <a:ext uri="{FF2B5EF4-FFF2-40B4-BE49-F238E27FC236}">
                <a16:creationId xmlns:a16="http://schemas.microsoft.com/office/drawing/2014/main" id="{A4885755-ED2D-4D4B-8E65-D85FD8C80BEC}"/>
              </a:ext>
            </a:extLst>
          </p:cNvPr>
          <p:cNvSpPr txBox="1"/>
          <p:nvPr/>
        </p:nvSpPr>
        <p:spPr>
          <a:xfrm>
            <a:off x="3886074" y="416760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53FA31BF-5AC5-442D-AB9B-836279AD2050}"/>
              </a:ext>
            </a:extLst>
          </p:cNvPr>
          <p:cNvCxnSpPr>
            <a:cxnSpLocks/>
          </p:cNvCxnSpPr>
          <p:nvPr/>
        </p:nvCxnSpPr>
        <p:spPr>
          <a:xfrm>
            <a:off x="4214460" y="4532703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TextBox 38">
            <a:extLst>
              <a:ext uri="{FF2B5EF4-FFF2-40B4-BE49-F238E27FC236}">
                <a16:creationId xmlns:a16="http://schemas.microsoft.com/office/drawing/2014/main" id="{F73D7CC0-70F0-4EBF-B82E-DFA64F412D14}"/>
              </a:ext>
            </a:extLst>
          </p:cNvPr>
          <p:cNvSpPr txBox="1"/>
          <p:nvPr/>
        </p:nvSpPr>
        <p:spPr>
          <a:xfrm>
            <a:off x="3886074" y="439063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03599067-F357-4BA4-8AE5-E920C3CDDF98}"/>
              </a:ext>
            </a:extLst>
          </p:cNvPr>
          <p:cNvCxnSpPr>
            <a:cxnSpLocks/>
          </p:cNvCxnSpPr>
          <p:nvPr/>
        </p:nvCxnSpPr>
        <p:spPr>
          <a:xfrm>
            <a:off x="4220596" y="3951746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TextBox 40">
            <a:extLst>
              <a:ext uri="{FF2B5EF4-FFF2-40B4-BE49-F238E27FC236}">
                <a16:creationId xmlns:a16="http://schemas.microsoft.com/office/drawing/2014/main" id="{04A5DF96-496F-4D94-AF21-48AC8F9A69A6}"/>
              </a:ext>
            </a:extLst>
          </p:cNvPr>
          <p:cNvSpPr txBox="1"/>
          <p:nvPr/>
        </p:nvSpPr>
        <p:spPr>
          <a:xfrm>
            <a:off x="3892210" y="380967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7B5B73BC-758F-4B7B-A3AE-3274327A62D8}"/>
              </a:ext>
            </a:extLst>
          </p:cNvPr>
          <p:cNvCxnSpPr>
            <a:cxnSpLocks/>
          </p:cNvCxnSpPr>
          <p:nvPr/>
        </p:nvCxnSpPr>
        <p:spPr>
          <a:xfrm>
            <a:off x="4214460" y="3746945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TextBox 42">
            <a:extLst>
              <a:ext uri="{FF2B5EF4-FFF2-40B4-BE49-F238E27FC236}">
                <a16:creationId xmlns:a16="http://schemas.microsoft.com/office/drawing/2014/main" id="{58BF8296-BD92-49BA-8E9E-BD23DB02565E}"/>
              </a:ext>
            </a:extLst>
          </p:cNvPr>
          <p:cNvSpPr txBox="1"/>
          <p:nvPr/>
        </p:nvSpPr>
        <p:spPr>
          <a:xfrm>
            <a:off x="3886074" y="359810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974961BB-EEB2-49D9-86B4-969443682F12}"/>
              </a:ext>
            </a:extLst>
          </p:cNvPr>
          <p:cNvCxnSpPr>
            <a:cxnSpLocks/>
          </p:cNvCxnSpPr>
          <p:nvPr/>
        </p:nvCxnSpPr>
        <p:spPr>
          <a:xfrm>
            <a:off x="4214460" y="3632707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1" name="TextBox 42">
            <a:extLst>
              <a:ext uri="{FF2B5EF4-FFF2-40B4-BE49-F238E27FC236}">
                <a16:creationId xmlns:a16="http://schemas.microsoft.com/office/drawing/2014/main" id="{B8CAF75E-07D4-4C80-BD56-3163061D29A7}"/>
              </a:ext>
            </a:extLst>
          </p:cNvPr>
          <p:cNvSpPr txBox="1"/>
          <p:nvPr/>
        </p:nvSpPr>
        <p:spPr>
          <a:xfrm>
            <a:off x="3801114" y="346520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700887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2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smin Carvalho Schäfer</dc:creator>
  <cp:lastModifiedBy>mnagata</cp:lastModifiedBy>
  <cp:revision>3</cp:revision>
  <dcterms:created xsi:type="dcterms:W3CDTF">2024-08-13T14:15:55Z</dcterms:created>
  <dcterms:modified xsi:type="dcterms:W3CDTF">2024-08-14T21:53:19Z</dcterms:modified>
</cp:coreProperties>
</file>